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B050"/>
    <a:srgbClr val="0066FF"/>
    <a:srgbClr val="D50505"/>
    <a:srgbClr val="F9B8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82" autoAdjust="0"/>
    <p:restoredTop sz="99769" autoAdjust="0"/>
  </p:normalViewPr>
  <p:slideViewPr>
    <p:cSldViewPr>
      <p:cViewPr varScale="1">
        <p:scale>
          <a:sx n="115" d="100"/>
          <a:sy n="115" d="100"/>
        </p:scale>
        <p:origin x="1884" y="108"/>
      </p:cViewPr>
      <p:guideLst>
        <p:guide orient="horz" pos="2160"/>
        <p:guide pos="2880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DA6AA9-4F33-46C6-B302-B5591502A1AB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A98017-DADE-4380-BED9-5B01BFC80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232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753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435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28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25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320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407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1856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0045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8626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34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2785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408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직사각형 8"/>
          <p:cNvSpPr/>
          <p:nvPr/>
        </p:nvSpPr>
        <p:spPr>
          <a:xfrm>
            <a:off x="635348" y="4777436"/>
            <a:ext cx="836050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Representative scatter plots from </a:t>
            </a:r>
            <a:r>
              <a:rPr lang="en-US" altLang="ko-KR" sz="1400" b="1" dirty="0" err="1">
                <a:latin typeface="Times New Roman" pitchFamily="18" charset="0"/>
                <a:cs typeface="Times New Roman" pitchFamily="18" charset="0"/>
              </a:rPr>
              <a:t>Fluidigm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 assay of the core markers.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Clear separation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between two homozygous genotypes.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wo genotypes were separated but one is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mis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-called as heterozygous genotype by the software, and further revised.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Heterozygous genotypes were called which is unusual in lettuce </a:t>
            </a:r>
            <a:r>
              <a:rPr lang="en-US" altLang="ko-KR" sz="1400" smtClean="0">
                <a:latin typeface="Times New Roman" pitchFamily="18" charset="0"/>
                <a:cs typeface="Times New Roman" pitchFamily="18" charset="0"/>
              </a:rPr>
              <a:t>genome. </a:t>
            </a:r>
            <a:r>
              <a:rPr lang="en-US" altLang="ko-KR" sz="140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x-axis and Y-axis indicate the florescence of HEX and FAM dye, respectively. Black dots, no template control (NTC); green and red dots, homozygous genotypes; blue dots, heterozygous genotypes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391483" y="1628112"/>
            <a:ext cx="8165463" cy="2789284"/>
            <a:chOff x="294969" y="2655939"/>
            <a:chExt cx="6963536" cy="2497789"/>
          </a:xfrm>
        </p:grpSpPr>
        <p:pic>
          <p:nvPicPr>
            <p:cNvPr id="17" name="그림 16"/>
            <p:cNvPicPr>
              <a:picLocks noChangeAspect="1"/>
            </p:cNvPicPr>
            <p:nvPr/>
          </p:nvPicPr>
          <p:blipFill rotWithShape="1">
            <a:blip r:embed="rId2"/>
            <a:srcRect l="3124" t="13033" r="3217"/>
            <a:stretch/>
          </p:blipFill>
          <p:spPr>
            <a:xfrm>
              <a:off x="651273" y="3007045"/>
              <a:ext cx="1914815" cy="2146683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3"/>
            <a:srcRect l="4165" t="13276" r="5033" b="1586"/>
            <a:stretch/>
          </p:blipFill>
          <p:spPr>
            <a:xfrm>
              <a:off x="2964014" y="3032589"/>
              <a:ext cx="1971187" cy="2121139"/>
            </a:xfrm>
            <a:prstGeom prst="rect">
              <a:avLst/>
            </a:prstGeom>
          </p:spPr>
        </p:pic>
        <p:sp>
          <p:nvSpPr>
            <p:cNvPr id="16" name="직사각형 15"/>
            <p:cNvSpPr/>
            <p:nvPr/>
          </p:nvSpPr>
          <p:spPr>
            <a:xfrm>
              <a:off x="3516598" y="2655939"/>
              <a:ext cx="80480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ctr"/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SNP032</a:t>
              </a:r>
            </a:p>
          </p:txBody>
        </p:sp>
        <p:pic>
          <p:nvPicPr>
            <p:cNvPr id="13" name="그림 12"/>
            <p:cNvPicPr>
              <a:picLocks noChangeAspect="1"/>
            </p:cNvPicPr>
            <p:nvPr/>
          </p:nvPicPr>
          <p:blipFill rotWithShape="1">
            <a:blip r:embed="rId4"/>
            <a:srcRect l="2643" t="12260" r="4457"/>
            <a:stretch/>
          </p:blipFill>
          <p:spPr>
            <a:xfrm>
              <a:off x="5314546" y="3007045"/>
              <a:ext cx="1943959" cy="2146683"/>
            </a:xfrm>
            <a:prstGeom prst="rect">
              <a:avLst/>
            </a:prstGeom>
          </p:spPr>
        </p:pic>
        <p:sp>
          <p:nvSpPr>
            <p:cNvPr id="14" name="직사각형 13"/>
            <p:cNvSpPr/>
            <p:nvPr/>
          </p:nvSpPr>
          <p:spPr>
            <a:xfrm>
              <a:off x="5882150" y="2655939"/>
              <a:ext cx="80480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ctr"/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SNP005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38939" y="4221086"/>
              <a:ext cx="572822" cy="33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XX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209387" y="3350627"/>
              <a:ext cx="572822" cy="33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YY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283970" y="4217173"/>
              <a:ext cx="6174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XX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034992" y="3422940"/>
              <a:ext cx="572822" cy="33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XY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428794" y="4382107"/>
              <a:ext cx="6174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XX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416843" y="3643084"/>
              <a:ext cx="572822" cy="33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XY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724132" y="3344110"/>
              <a:ext cx="6174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Times New Roman" pitchFamily="18" charset="0"/>
                  <a:cs typeface="Times New Roman" pitchFamily="18" charset="0"/>
                </a:rPr>
                <a:t>[YY]</a:t>
              </a:r>
              <a:endParaRPr lang="ko-KR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27785" y="2994493"/>
              <a:ext cx="303662" cy="4001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ko-KR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004050" y="2994492"/>
              <a:ext cx="276895" cy="4001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ko-KR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294969" y="2994491"/>
              <a:ext cx="290277" cy="4001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20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ko-KR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1275891" y="2655940"/>
              <a:ext cx="80480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ctr"/>
              <a:r>
                <a:rPr lang="en-US" altLang="ko-KR" sz="1600" dirty="0">
                  <a:latin typeface="Times New Roman" pitchFamily="18" charset="0"/>
                  <a:cs typeface="Times New Roman" pitchFamily="18" charset="0"/>
                </a:rPr>
                <a:t>SNP03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77427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0</TotalTime>
  <Words>120</Words>
  <Application>Microsoft Office PowerPoint</Application>
  <PresentationFormat>화면 슬라이드 쇼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SNP markers for genetic diversity assessment in lettuce varieties (Lactuca sativa L.)</dc:title>
  <dc:creator>User</dc:creator>
  <cp:lastModifiedBy>User</cp:lastModifiedBy>
  <cp:revision>355</cp:revision>
  <cp:lastPrinted>2021-06-21T07:24:34Z</cp:lastPrinted>
  <dcterms:created xsi:type="dcterms:W3CDTF">2020-06-02T04:33:11Z</dcterms:created>
  <dcterms:modified xsi:type="dcterms:W3CDTF">2021-12-24T08:04:18Z</dcterms:modified>
</cp:coreProperties>
</file>